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43" autoAdjust="0"/>
    <p:restoredTop sz="94660"/>
  </p:normalViewPr>
  <p:slideViewPr>
    <p:cSldViewPr snapToGrid="0">
      <p:cViewPr varScale="1">
        <p:scale>
          <a:sx n="73" d="100"/>
          <a:sy n="73" d="100"/>
        </p:scale>
        <p:origin x="307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52870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32074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5755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05635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81738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77210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84657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420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85331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56622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91152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09238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479" y="509275"/>
            <a:ext cx="3880421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r>
              <a:rPr lang="en-US" b="1" u="sng" cap="none" spc="0" dirty="0" smtClean="0">
                <a:ln w="0"/>
              </a:rPr>
              <a:t>Supplementary Figure 1 – IHC controls </a:t>
            </a:r>
            <a:endParaRPr lang="en-US" b="1" u="sng" cap="none" spc="0" dirty="0">
              <a:ln w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35951" y="1056064"/>
            <a:ext cx="3852198" cy="6084674"/>
            <a:chOff x="235951" y="1056064"/>
            <a:chExt cx="3852198" cy="608467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2836" y="1275517"/>
              <a:ext cx="1195313" cy="9000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06147" y="1275517"/>
              <a:ext cx="1195313" cy="90000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2835" y="2638662"/>
              <a:ext cx="1195313" cy="9000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76557" y="4031300"/>
              <a:ext cx="1195313" cy="9000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6144" y="4040756"/>
              <a:ext cx="1195313" cy="9000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6145" y="2624940"/>
              <a:ext cx="1195313" cy="900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76557" y="6194572"/>
              <a:ext cx="1195313" cy="900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98866" y="6194572"/>
              <a:ext cx="1195313" cy="9000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570394" y="6771406"/>
              <a:ext cx="8111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dirty="0" smtClean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Rabbit serum</a:t>
              </a:r>
              <a:endParaRPr lang="en-IE" sz="9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831129" y="6771406"/>
              <a:ext cx="8111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900" b="1" dirty="0" smtClean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Mouse serum</a:t>
              </a:r>
              <a:endParaRPr lang="en-IE" sz="9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02760" y="2157961"/>
              <a:ext cx="356911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Anti-IL-36</a:t>
              </a:r>
              <a:r>
                <a:rPr lang="el-GR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                             +                                       +        </a:t>
              </a:r>
            </a:p>
            <a:p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Recombinant IL-36</a:t>
              </a:r>
              <a:r>
                <a:rPr lang="el-GR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             -                                        +</a:t>
              </a:r>
              <a:endParaRPr lang="en-IE" sz="11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02760" y="3506079"/>
              <a:ext cx="3569110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Anti-IL-36</a:t>
              </a:r>
              <a:r>
                <a:rPr lang="el-GR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                             +                                       +        </a:t>
              </a:r>
            </a:p>
            <a:p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Recombinant IL-36</a:t>
              </a:r>
              <a:r>
                <a:rPr lang="el-GR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             -                                       +</a:t>
              </a:r>
              <a:endParaRPr lang="en-IE" sz="11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02760" y="4969449"/>
              <a:ext cx="3569110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Anti-IL-36</a:t>
              </a:r>
              <a:r>
                <a:rPr lang="el-GR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γ</a:t>
              </a:r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                             +                                      +        </a:t>
              </a:r>
            </a:p>
            <a:p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Recombinant IL-36</a:t>
              </a:r>
              <a:r>
                <a:rPr lang="el-GR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γ</a:t>
              </a:r>
              <a:r>
                <a:rPr lang="en-IE" sz="11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             -                                       +</a:t>
              </a:r>
              <a:endParaRPr lang="en-IE" sz="11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35951" y="1056064"/>
              <a:ext cx="6206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i="1" dirty="0" smtClean="0">
                  <a:latin typeface="Arial" pitchFamily="34" charset="0"/>
                  <a:cs typeface="Arial" pitchFamily="34" charset="0"/>
                </a:rPr>
                <a:t>A)</a:t>
              </a:r>
              <a:endParaRPr lang="en-GB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67431" y="6063487"/>
              <a:ext cx="6206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i="1" dirty="0" smtClean="0">
                  <a:latin typeface="Arial" pitchFamily="34" charset="0"/>
                  <a:cs typeface="Arial" pitchFamily="34" charset="0"/>
                </a:rPr>
                <a:t>B)</a:t>
              </a:r>
              <a:endParaRPr lang="en-GB" b="1" i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55048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47ACFEC197F5343A63F26F72B2BAB67" ma:contentTypeVersion="15" ma:contentTypeDescription="Create a new document." ma:contentTypeScope="" ma:versionID="7a16da86f4c39566f154ba47cf607f99">
  <xsd:schema xmlns:xsd="http://www.w3.org/2001/XMLSchema" xmlns:xs="http://www.w3.org/2001/XMLSchema" xmlns:p="http://schemas.microsoft.com/office/2006/metadata/properties" xmlns:ns1="http://schemas.microsoft.com/sharepoint/v3" xmlns:ns3="bbcb7b64-6de8-4ed1-81fe-5e09c6fb67ad" xmlns:ns4="c0e1ee63-e7db-4ec9-8fd3-22d771cf9ac5" targetNamespace="http://schemas.microsoft.com/office/2006/metadata/properties" ma:root="true" ma:fieldsID="aaa4f386fbd43a103df839d05f99d257" ns1:_="" ns3:_="" ns4:_="">
    <xsd:import namespace="http://schemas.microsoft.com/sharepoint/v3"/>
    <xsd:import namespace="bbcb7b64-6de8-4ed1-81fe-5e09c6fb67ad"/>
    <xsd:import namespace="c0e1ee63-e7db-4ec9-8fd3-22d771cf9ac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1:_ip_UnifiedCompliancePolicyProperties" minOccurs="0"/>
                <xsd:element ref="ns1:_ip_UnifiedCompliancePolicyUIAction" minOccurs="0"/>
                <xsd:element ref="ns3:MediaServiceEventHashCode" minOccurs="0"/>
                <xsd:element ref="ns3:MediaServiceGenerationTime" minOccurs="0"/>
                <xsd:element ref="ns3:MediaServiceOCR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6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7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bcb7b64-6de8-4ed1-81fe-5e09c6fb67a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2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e1ee63-e7db-4ec9-8fd3-22d771cf9ac5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5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FF893744-D87E-40A8-B9FA-2014FADE90E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bbcb7b64-6de8-4ed1-81fe-5e09c6fb67ad"/>
    <ds:schemaRef ds:uri="c0e1ee63-e7db-4ec9-8fd3-22d771cf9ac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D460871-251F-45C1-99A4-36F6401276A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1EDC3A8-6D2C-4BA8-97DC-AF7D3E94E560}">
  <ds:schemaRefs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documentManagement/types"/>
    <ds:schemaRef ds:uri="c0e1ee63-e7db-4ec9-8fd3-22d771cf9ac5"/>
    <ds:schemaRef ds:uri="http://schemas.microsoft.com/sharepoint/v3"/>
    <ds:schemaRef ds:uri="bbcb7b64-6de8-4ed1-81fe-5e09c6fb67ad"/>
    <ds:schemaRef ds:uri="http://purl.org/dc/terms/"/>
    <ds:schemaRef ds:uri="http://schemas.openxmlformats.org/package/2006/metadata/core-properties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1</TotalTime>
  <Words>41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T Servi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hologyUser</dc:creator>
  <cp:lastModifiedBy>Houston, Aileen</cp:lastModifiedBy>
  <cp:revision>12</cp:revision>
  <dcterms:created xsi:type="dcterms:W3CDTF">2021-10-08T11:27:23Z</dcterms:created>
  <dcterms:modified xsi:type="dcterms:W3CDTF">2022-03-11T12:16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7ACFEC197F5343A63F26F72B2BAB67</vt:lpwstr>
  </property>
</Properties>
</file>